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-960" y="18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34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5840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3145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0862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7247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6895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1152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9092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6582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9483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7557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CB396-B279-4AC5-97E9-9E215682DFD6}" type="datetimeFigureOut">
              <a:rPr lang="es-ES" smtClean="0"/>
              <a:t>10/06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74914-EB52-4274-BF7C-3A4A6A5E11F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5827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1841146" y="2513599"/>
            <a:ext cx="900000" cy="12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166751" y="2513600"/>
            <a:ext cx="900000" cy="12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4485475" y="2513600"/>
            <a:ext cx="900000" cy="12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1841146" y="3502692"/>
            <a:ext cx="900000" cy="12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166752" y="3502692"/>
            <a:ext cx="900000" cy="12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4485475" y="3502691"/>
            <a:ext cx="900000" cy="12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12 CuadroTexto"/>
          <p:cNvSpPr txBox="1"/>
          <p:nvPr/>
        </p:nvSpPr>
        <p:spPr>
          <a:xfrm>
            <a:off x="5565475" y="3020488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ºC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5562196" y="4009580"/>
            <a:ext cx="437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ºC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1996033" y="2396952"/>
            <a:ext cx="6527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CD-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ra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>
            <a:off x="3116576" y="2396952"/>
            <a:ext cx="9829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CD-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r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p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>
            <a:off x="4469033" y="2396952"/>
            <a:ext cx="9637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CD-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r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u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87"/>
          <p:cNvSpPr txBox="1">
            <a:spLocks noChangeArrowheads="1"/>
          </p:cNvSpPr>
          <p:nvPr/>
        </p:nvSpPr>
        <p:spPr bwMode="auto">
          <a:xfrm>
            <a:off x="1104583" y="2754953"/>
            <a:ext cx="556563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altLang="es-ES" sz="9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6" name="Text Box 88"/>
          <p:cNvSpPr txBox="1">
            <a:spLocks noChangeArrowheads="1"/>
          </p:cNvSpPr>
          <p:nvPr/>
        </p:nvSpPr>
        <p:spPr bwMode="auto">
          <a:xfrm>
            <a:off x="1155879" y="3038066"/>
            <a:ext cx="50526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altLang="es-ES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DH1</a:t>
            </a:r>
            <a:endParaRPr lang="es-ES" altLang="es-E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88"/>
          <p:cNvSpPr txBox="1">
            <a:spLocks noChangeArrowheads="1"/>
          </p:cNvSpPr>
          <p:nvPr/>
        </p:nvSpPr>
        <p:spPr bwMode="auto">
          <a:xfrm>
            <a:off x="1155879" y="3339346"/>
            <a:ext cx="50526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altLang="es-ES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DH2</a:t>
            </a:r>
            <a:endParaRPr lang="es-ES" altLang="es-E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87"/>
          <p:cNvSpPr txBox="1">
            <a:spLocks noChangeArrowheads="1"/>
          </p:cNvSpPr>
          <p:nvPr/>
        </p:nvSpPr>
        <p:spPr bwMode="auto">
          <a:xfrm>
            <a:off x="1104583" y="3693224"/>
            <a:ext cx="556563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altLang="es-ES" sz="9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0" name="Text Box 88"/>
          <p:cNvSpPr txBox="1">
            <a:spLocks noChangeArrowheads="1"/>
          </p:cNvSpPr>
          <p:nvPr/>
        </p:nvSpPr>
        <p:spPr bwMode="auto">
          <a:xfrm>
            <a:off x="1155879" y="4012912"/>
            <a:ext cx="50526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altLang="es-ES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DH1</a:t>
            </a:r>
            <a:endParaRPr lang="es-ES" altLang="es-E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88"/>
          <p:cNvSpPr txBox="1">
            <a:spLocks noChangeArrowheads="1"/>
          </p:cNvSpPr>
          <p:nvPr/>
        </p:nvSpPr>
        <p:spPr bwMode="auto">
          <a:xfrm>
            <a:off x="1155879" y="4305913"/>
            <a:ext cx="50526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s-ES" altLang="es-ES" sz="9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DH2</a:t>
            </a:r>
            <a:endParaRPr lang="es-ES" altLang="es-E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2 CuadroTexto"/>
          <p:cNvSpPr txBox="1"/>
          <p:nvPr/>
        </p:nvSpPr>
        <p:spPr>
          <a:xfrm>
            <a:off x="1355371" y="4932040"/>
            <a:ext cx="4505369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reased availability of aspartate or glutamate does not alter the cold growth phenotype provided by ectopic express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H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H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YEplac195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RA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ontrol, empty plasmid), YEpGDH1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H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YEpGDH2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DH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forman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CEN.PK2-1C wild-type strain were assayed for growth at low temperature. Cultures were incubated on SCD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30°C until the exponential phase and were adjusted to OD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1.0. Then, serial dilutions (1–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the cultures were spotted (3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to SCD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ar medium supplemented with 80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of aspartate (SCD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Asp) or glutamate (SCD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incubated at 30°C for 2 days or at 15°C for 10 days. A representative experiment is shown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1407792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48</Words>
  <Application>Microsoft Office PowerPoint</Application>
  <PresentationFormat>Presentación en pantalla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tcpaq</dc:creator>
  <cp:lastModifiedBy>btcpri</cp:lastModifiedBy>
  <cp:revision>4</cp:revision>
  <dcterms:created xsi:type="dcterms:W3CDTF">2015-06-10T10:05:33Z</dcterms:created>
  <dcterms:modified xsi:type="dcterms:W3CDTF">2015-06-10T14:16:40Z</dcterms:modified>
</cp:coreProperties>
</file>